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545"/>
  </p:normalViewPr>
  <p:slideViewPr>
    <p:cSldViewPr snapToGrid="0" snapToObjects="1">
      <p:cViewPr varScale="1">
        <p:scale>
          <a:sx n="108" d="100"/>
          <a:sy n="108" d="100"/>
        </p:scale>
        <p:origin x="7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tarfish/Desktop/&#26700;&#38754;/&#20020;&#24202;&#35838;&#39064;/Type2%20DM%20and%20pneumonia/data%20amended/&#24494;&#29983;&#29289;&#23398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3478861250991087E-2"/>
          <c:y val="8.9758971650808449E-3"/>
          <c:w val="0.93652113874900889"/>
          <c:h val="0.7480164367457570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D$1</c:f>
              <c:strCache>
                <c:ptCount val="1"/>
                <c:pt idx="0">
                  <c:v>SCAP（n=109）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2:$B$32</c:f>
              <c:strCache>
                <c:ptCount val="31"/>
                <c:pt idx="0">
                  <c:v>  Staphylococcus aureus</c:v>
                </c:pt>
                <c:pt idx="1">
                  <c:v>  Staphylococcus capitis</c:v>
                </c:pt>
                <c:pt idx="2">
                  <c:v>  Staphylococcus hominis</c:v>
                </c:pt>
                <c:pt idx="3">
                  <c:v>  Staphylococcus haemolyticus</c:v>
                </c:pt>
                <c:pt idx="4">
                  <c:v>  Enterococcus faecium</c:v>
                </c:pt>
                <c:pt idx="5">
                  <c:v>  Others</c:v>
                </c:pt>
                <c:pt idx="6">
                  <c:v>  Klebsiella pneumoniae</c:v>
                </c:pt>
                <c:pt idx="7">
                  <c:v>  E. coli</c:v>
                </c:pt>
                <c:pt idx="8">
                  <c:v>  Pseudomonas aeruginosa</c:v>
                </c:pt>
                <c:pt idx="9">
                  <c:v>  Enterobacter aerogenes</c:v>
                </c:pt>
                <c:pt idx="10">
                  <c:v>  Enterobacter cloacae</c:v>
                </c:pt>
                <c:pt idx="11">
                  <c:v>  Serratia marcescens</c:v>
                </c:pt>
                <c:pt idx="12">
                  <c:v>Chryseobacterium meningosepticum</c:v>
                </c:pt>
                <c:pt idx="13">
                  <c:v>  Burkholderia multivorans</c:v>
                </c:pt>
                <c:pt idx="14">
                  <c:v>  Others</c:v>
                </c:pt>
                <c:pt idx="15">
                  <c:v> Influenza virus A</c:v>
                </c:pt>
                <c:pt idx="16">
                  <c:v> Influenza virus B</c:v>
                </c:pt>
                <c:pt idx="17">
                  <c:v> Parainfluenza virus</c:v>
                </c:pt>
                <c:pt idx="18">
                  <c:v> Respiratory syncytial virus A</c:v>
                </c:pt>
                <c:pt idx="19">
                  <c:v> Respiratory syncytial virus B</c:v>
                </c:pt>
                <c:pt idx="20">
                  <c:v> Adenovirus</c:v>
                </c:pt>
                <c:pt idx="21">
                  <c:v> Cytomegalovirus</c:v>
                </c:pt>
                <c:pt idx="22">
                  <c:v> Epstein-Barr virus</c:v>
                </c:pt>
                <c:pt idx="23">
                  <c:v> Herpes simplex virus</c:v>
                </c:pt>
                <c:pt idx="24">
                  <c:v> Human papillomavirus</c:v>
                </c:pt>
                <c:pt idx="25">
                  <c:v> Coronavirus</c:v>
                </c:pt>
                <c:pt idx="26">
                  <c:v> Aspergillosis</c:v>
                </c:pt>
                <c:pt idx="27">
                  <c:v> Pneumocystis jiroveci</c:v>
                </c:pt>
                <c:pt idx="28">
                  <c:v>Mycoplasma pneumoniae</c:v>
                </c:pt>
                <c:pt idx="29">
                  <c:v>Legionella pneumophila</c:v>
                </c:pt>
                <c:pt idx="30">
                  <c:v>Rickettsia</c:v>
                </c:pt>
              </c:strCache>
            </c:strRef>
          </c:cat>
          <c:val>
            <c:numRef>
              <c:f>Sheet1!$D$2:$D$32</c:f>
              <c:numCache>
                <c:formatCode>General</c:formatCode>
                <c:ptCount val="31"/>
                <c:pt idx="0">
                  <c:v>8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4</c:v>
                </c:pt>
                <c:pt idx="6">
                  <c:v>9</c:v>
                </c:pt>
                <c:pt idx="7">
                  <c:v>4</c:v>
                </c:pt>
                <c:pt idx="8">
                  <c:v>2</c:v>
                </c:pt>
                <c:pt idx="9">
                  <c:v>1</c:v>
                </c:pt>
                <c:pt idx="10">
                  <c:v>1</c:v>
                </c:pt>
                <c:pt idx="11">
                  <c:v>0</c:v>
                </c:pt>
                <c:pt idx="12">
                  <c:v>1</c:v>
                </c:pt>
                <c:pt idx="13">
                  <c:v>1</c:v>
                </c:pt>
                <c:pt idx="14">
                  <c:v>3</c:v>
                </c:pt>
                <c:pt idx="15">
                  <c:v>5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2</c:v>
                </c:pt>
                <c:pt idx="20">
                  <c:v>3</c:v>
                </c:pt>
                <c:pt idx="21">
                  <c:v>8</c:v>
                </c:pt>
                <c:pt idx="22">
                  <c:v>3</c:v>
                </c:pt>
                <c:pt idx="23">
                  <c:v>1</c:v>
                </c:pt>
                <c:pt idx="24">
                  <c:v>1</c:v>
                </c:pt>
                <c:pt idx="25">
                  <c:v>2</c:v>
                </c:pt>
                <c:pt idx="26">
                  <c:v>3</c:v>
                </c:pt>
                <c:pt idx="27">
                  <c:v>1</c:v>
                </c:pt>
                <c:pt idx="28">
                  <c:v>2</c:v>
                </c:pt>
                <c:pt idx="29">
                  <c:v>1</c:v>
                </c:pt>
                <c:pt idx="3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F3-954F-B575-791BBC7440BC}"/>
            </c:ext>
          </c:extLst>
        </c:ser>
        <c:ser>
          <c:idx val="1"/>
          <c:order val="1"/>
          <c:tx>
            <c:strRef>
              <c:f>Sheet1!$E$1</c:f>
              <c:strCache>
                <c:ptCount val="1"/>
                <c:pt idx="0">
                  <c:v>non-SCAP（n=99）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2:$B$32</c:f>
              <c:strCache>
                <c:ptCount val="31"/>
                <c:pt idx="0">
                  <c:v>  Staphylococcus aureus</c:v>
                </c:pt>
                <c:pt idx="1">
                  <c:v>  Staphylococcus capitis</c:v>
                </c:pt>
                <c:pt idx="2">
                  <c:v>  Staphylococcus hominis</c:v>
                </c:pt>
                <c:pt idx="3">
                  <c:v>  Staphylococcus haemolyticus</c:v>
                </c:pt>
                <c:pt idx="4">
                  <c:v>  Enterococcus faecium</c:v>
                </c:pt>
                <c:pt idx="5">
                  <c:v>  Others</c:v>
                </c:pt>
                <c:pt idx="6">
                  <c:v>  Klebsiella pneumoniae</c:v>
                </c:pt>
                <c:pt idx="7">
                  <c:v>  E. coli</c:v>
                </c:pt>
                <c:pt idx="8">
                  <c:v>  Pseudomonas aeruginosa</c:v>
                </c:pt>
                <c:pt idx="9">
                  <c:v>  Enterobacter aerogenes</c:v>
                </c:pt>
                <c:pt idx="10">
                  <c:v>  Enterobacter cloacae</c:v>
                </c:pt>
                <c:pt idx="11">
                  <c:v>  Serratia marcescens</c:v>
                </c:pt>
                <c:pt idx="12">
                  <c:v>Chryseobacterium meningosepticum</c:v>
                </c:pt>
                <c:pt idx="13">
                  <c:v>  Burkholderia multivorans</c:v>
                </c:pt>
                <c:pt idx="14">
                  <c:v>  Others</c:v>
                </c:pt>
                <c:pt idx="15">
                  <c:v> Influenza virus A</c:v>
                </c:pt>
                <c:pt idx="16">
                  <c:v> Influenza virus B</c:v>
                </c:pt>
                <c:pt idx="17">
                  <c:v> Parainfluenza virus</c:v>
                </c:pt>
                <c:pt idx="18">
                  <c:v> Respiratory syncytial virus A</c:v>
                </c:pt>
                <c:pt idx="19">
                  <c:v> Respiratory syncytial virus B</c:v>
                </c:pt>
                <c:pt idx="20">
                  <c:v> Adenovirus</c:v>
                </c:pt>
                <c:pt idx="21">
                  <c:v> Cytomegalovirus</c:v>
                </c:pt>
                <c:pt idx="22">
                  <c:v> Epstein-Barr virus</c:v>
                </c:pt>
                <c:pt idx="23">
                  <c:v> Herpes simplex virus</c:v>
                </c:pt>
                <c:pt idx="24">
                  <c:v> Human papillomavirus</c:v>
                </c:pt>
                <c:pt idx="25">
                  <c:v> Coronavirus</c:v>
                </c:pt>
                <c:pt idx="26">
                  <c:v> Aspergillosis</c:v>
                </c:pt>
                <c:pt idx="27">
                  <c:v> Pneumocystis jiroveci</c:v>
                </c:pt>
                <c:pt idx="28">
                  <c:v>Mycoplasma pneumoniae</c:v>
                </c:pt>
                <c:pt idx="29">
                  <c:v>Legionella pneumophila</c:v>
                </c:pt>
                <c:pt idx="30">
                  <c:v>Rickettsia</c:v>
                </c:pt>
              </c:strCache>
            </c:strRef>
          </c:cat>
          <c:val>
            <c:numRef>
              <c:f>Sheet1!$E$2:$E$32</c:f>
              <c:numCache>
                <c:formatCode>General</c:formatCode>
                <c:ptCount val="31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4</c:v>
                </c:pt>
                <c:pt idx="7">
                  <c:v>1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0</c:v>
                </c:pt>
                <c:pt idx="13">
                  <c:v>0</c:v>
                </c:pt>
                <c:pt idx="14">
                  <c:v>2</c:v>
                </c:pt>
                <c:pt idx="15">
                  <c:v>1</c:v>
                </c:pt>
                <c:pt idx="16">
                  <c:v>0</c:v>
                </c:pt>
                <c:pt idx="17">
                  <c:v>0</c:v>
                </c:pt>
                <c:pt idx="18">
                  <c:v>1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</c:v>
                </c:pt>
                <c:pt idx="24">
                  <c:v>0</c:v>
                </c:pt>
                <c:pt idx="25">
                  <c:v>0</c:v>
                </c:pt>
                <c:pt idx="26">
                  <c:v>1</c:v>
                </c:pt>
                <c:pt idx="27">
                  <c:v>0</c:v>
                </c:pt>
                <c:pt idx="28">
                  <c:v>5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BF3-954F-B575-791BBC7440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100"/>
        <c:axId val="1061513088"/>
        <c:axId val="1121830560"/>
      </c:barChart>
      <c:catAx>
        <c:axId val="1061513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Microsoft YaHei" panose="020B0503020204020204" pitchFamily="34" charset="-122"/>
                <a:cs typeface="Times New Roman" panose="02020603050405020304" pitchFamily="18" charset="0"/>
              </a:defRPr>
            </a:pPr>
            <a:endParaRPr lang="zh-CN"/>
          </a:p>
        </c:txPr>
        <c:crossAx val="1121830560"/>
        <c:crosses val="autoZero"/>
        <c:auto val="1"/>
        <c:lblAlgn val="ctr"/>
        <c:lblOffset val="100"/>
        <c:noMultiLvlLbl val="0"/>
      </c:catAx>
      <c:valAx>
        <c:axId val="11218305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200" dirty="0"/>
                  <a:t>Number</a:t>
                </a:r>
                <a:r>
                  <a:rPr lang="en-US" altLang="zh-CN" sz="1200" baseline="0" dirty="0"/>
                  <a:t> of patients</a:t>
                </a:r>
                <a:endParaRPr lang="zh-CN" altLang="en-US" sz="1200" dirty="0"/>
              </a:p>
            </c:rich>
          </c:tx>
          <c:layout>
            <c:manualLayout>
              <c:xMode val="edge"/>
              <c:yMode val="edge"/>
              <c:x val="4.1490044118964009E-2"/>
              <c:y val="0.2313392739114428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0615130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7061961345740874"/>
          <c:y val="0.96241806437204469"/>
          <c:w val="0.29669892627057981"/>
          <c:h val="3.75819356279553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F27604-C959-BD4E-8DC3-628E968D1E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4E3E551-A90C-2A49-879A-1951D5A497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357F86-9008-8D41-94CB-8E09D360C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29A7E6-90F5-9A40-97F5-3EBD20713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3F90306-8D61-D44F-A055-B8B8DDA57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97576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371E15-39A0-444E-BB6E-238415F274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2E8F08D-2FDE-624D-A63B-DD065C8615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5FB41A-6301-A544-AB18-168EF34DF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1BBFE5-F407-CB46-82F6-1CC664D82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0EA367-813E-6340-A2DB-7D01AE4E0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31154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1C43882-EB56-534E-80B7-8737726666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50C4A8B-AC02-4E43-9B26-161A9AD6CC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065081-8486-5A42-84F9-EB6BDA70A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3294D4-750B-4442-B5D4-15BA1542E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ED7C721-C351-4B4D-B499-4F81FB385F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35187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53A8AA-E207-6041-A658-EC81BD1796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8DF8809-6219-2442-BB79-21428F3C7B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183094-6B43-5940-83C9-FB3A81355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EBEE61F-9BE1-9740-980C-FDB51908F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0E4A80-1484-1046-AB41-F9E16ED3B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39176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035619-F87A-E24D-86B1-CB99B8BC69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978B37C-06A0-4843-AB11-E45E822FF4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DB8B76-EA46-6C40-A38E-2CF36871E0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2EE398C-0249-0B46-8827-929FF181B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23FFD5C-CBA5-C748-B3C4-6FFD186EB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68981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9F6EAF-D657-E242-899E-19D2C77237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2BE532-BE12-8D4F-A017-E7D0BC734C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D3BBC41-6953-9C49-A794-5A032C58C4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7DCF2C-5D53-2645-AABF-FFF7660F5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FAEB3E-450C-1640-8853-FC3DB5060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AF4EE53-3378-D248-9FA4-639AC183F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84631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FB1CFB-4F47-D748-A423-A52AEBB459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2C786F9-FD6D-3A4F-A68A-845EF60484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F7647B7-6052-A043-9FEF-96C9241422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C92231D-EC2D-6240-B9E2-D2A8F3C928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ECD0D2F-BFD0-F64E-98A9-A33C0205AB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C7557C2-7008-7146-B28E-0B1A59809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30A781B-B54E-7F47-AE82-FC1933316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1E89890-4B07-CA40-90E3-5679DFE93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33737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BDAA90-F176-314B-BEDA-0390B0AA4A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EDFD766-D0EA-F84D-BFDD-9DBE5789A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5067882-3BE5-E540-8CFE-FB43AEAC96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20CF143-E602-9140-B96B-EEF8BBF04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33390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F1B3070-C9AC-9842-B6C1-71966AB7D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94879AE-1C35-A347-848D-5CFCD7AAC9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2D2F836-646B-0B49-AD45-DE46F2CE9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21612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443664-3C55-7541-8EFA-A5522F594D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FE421F3-1798-3448-BD00-A679485CB5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F3A2724-B7F1-684E-833D-6ED1D10077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4FF6294-C21E-CA49-B8D3-1B5625AEA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586323B-AE19-C24D-9947-F1C971BE80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039D391-330B-4F4B-9E64-D05E932D3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46326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A8B664-7A11-2647-A073-8F202E7B85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A552598-3251-194C-A3A2-D4518A6C0C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4A61DB9-F16B-CB4D-8BAE-295FEF78DF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E6FD083-2259-5B4C-8274-B4041E931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5F21816-5C73-2543-8505-B43107BF0D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C2F659E-754C-3846-8E59-DE19E864B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48671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8F06F39-187B-E043-9F8E-61F7AD2F7A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08571C5-E153-A84A-A7D7-F459B09F1F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222B64-40D2-F14F-A105-DAAA708693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2265DB-AFC3-104A-B761-0F2570191E7B}" type="datetimeFigureOut">
              <a:t>2021/2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A6555D-08ED-6B47-A3B4-6CCC510B62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683D245-A161-3645-9B26-6B03EE0A25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FC4C4-BA18-1A44-99AB-C6B0845D2EB1}" type="slidenum"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95586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B05CECE5-C320-8C40-B177-85DED98EC5FD}"/>
              </a:ext>
            </a:extLst>
          </p:cNvPr>
          <p:cNvGrpSpPr/>
          <p:nvPr/>
        </p:nvGrpSpPr>
        <p:grpSpPr>
          <a:xfrm>
            <a:off x="613610" y="914401"/>
            <a:ext cx="10407316" cy="5628184"/>
            <a:chOff x="613610" y="914401"/>
            <a:chExt cx="10407316" cy="5628184"/>
          </a:xfrm>
        </p:grpSpPr>
        <p:graphicFrame>
          <p:nvGraphicFramePr>
            <p:cNvPr id="4" name="图表 3">
              <a:extLst>
                <a:ext uri="{FF2B5EF4-FFF2-40B4-BE49-F238E27FC236}">
                  <a16:creationId xmlns:a16="http://schemas.microsoft.com/office/drawing/2014/main" id="{C103E380-14F3-754A-AB66-0B6D8318173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15732864"/>
                </p:ext>
              </p:extLst>
            </p:nvPr>
          </p:nvGraphicFramePr>
          <p:xfrm>
            <a:off x="613610" y="914401"/>
            <a:ext cx="10407316" cy="56281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41D1206E-B0D6-3D41-B95F-9C228F93C876}"/>
                </a:ext>
              </a:extLst>
            </p:cNvPr>
            <p:cNvSpPr txBox="1"/>
            <p:nvPr/>
          </p:nvSpPr>
          <p:spPr>
            <a:xfrm>
              <a:off x="1780674" y="1888958"/>
              <a:ext cx="132347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zh-CN" b="1" dirty="0"/>
                <a:t>*</a:t>
              </a:r>
              <a:endParaRPr kumimoji="1" lang="zh-CN" altLang="en-US" b="1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6FF855D1-F41C-2248-A12A-6E0CA92CE740}"/>
                </a:ext>
              </a:extLst>
            </p:cNvPr>
            <p:cNvSpPr txBox="1"/>
            <p:nvPr/>
          </p:nvSpPr>
          <p:spPr>
            <a:xfrm>
              <a:off x="8057148" y="2073624"/>
              <a:ext cx="132347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zh-CN" b="1" dirty="0"/>
                <a:t>*</a:t>
              </a:r>
              <a:endParaRPr kumimoji="1" lang="zh-CN" alt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960444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5</Words>
  <Application>Microsoft Macintosh PowerPoint</Application>
  <PresentationFormat>宽屏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892</dc:creator>
  <cp:lastModifiedBy>Service E-mail</cp:lastModifiedBy>
  <cp:revision>6</cp:revision>
  <dcterms:created xsi:type="dcterms:W3CDTF">2020-11-23T14:11:10Z</dcterms:created>
  <dcterms:modified xsi:type="dcterms:W3CDTF">2021-02-05T05:20:55Z</dcterms:modified>
</cp:coreProperties>
</file>